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80" d="100"/>
          <a:sy n="80" d="100"/>
        </p:scale>
        <p:origin x="37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2DAD419-E5FE-5306-CF71-82D340F6F0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pt-BR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89681972-83FC-B68F-28C0-E1C5D2E47D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pt-BR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41AFAC6-0FC9-7A5A-13B4-1D8836D4C4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8DCC-8482-4F17-A55C-80CAFC6C22FC}" type="datetimeFigureOut">
              <a:rPr lang="pt-BR" smtClean="0"/>
              <a:t>17/08/2022</a:t>
            </a:fld>
            <a:endParaRPr lang="pt-B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C6999F8-F68C-FDD4-92FC-34AD3F4346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300E3D3-4BD8-CEEF-E289-ABDB765AF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6187-DDB6-4281-8E35-2EC75AFE2CAF}" type="slidenum">
              <a:rPr lang="pt-BR" smtClean="0"/>
              <a:t>‹N°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30636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90BEB64-6AF7-2CF3-564E-6E3AD6BDCB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pt-BR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C7C2B9B-FF0E-BAA7-7EF8-12DABE3BA0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pt-BR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2724D77-3B8F-C17F-F3DE-869E364889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8DCC-8482-4F17-A55C-80CAFC6C22FC}" type="datetimeFigureOut">
              <a:rPr lang="pt-BR" smtClean="0"/>
              <a:t>17/08/2022</a:t>
            </a:fld>
            <a:endParaRPr lang="pt-B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0AA0804-6305-C402-6F7F-21A982E32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763F212-C3FE-62C4-C581-07FBAD08D2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6187-DDB6-4281-8E35-2EC75AFE2CAF}" type="slidenum">
              <a:rPr lang="pt-BR" smtClean="0"/>
              <a:t>‹N°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52114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CA055F0D-8290-ED1F-9D4C-802B28C2A6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pt-BR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3E35FB3-3084-5809-2EF6-5315A6177F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pt-BR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A6F7BC6-7E0B-5880-893C-AC5177F1F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8DCC-8482-4F17-A55C-80CAFC6C22FC}" type="datetimeFigureOut">
              <a:rPr lang="pt-BR" smtClean="0"/>
              <a:t>17/08/2022</a:t>
            </a:fld>
            <a:endParaRPr lang="pt-B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A3C9C59-506C-6B33-F580-FDE65FB084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5EC3D86-F7F0-9533-9C1B-163C5A378A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6187-DDB6-4281-8E35-2EC75AFE2CAF}" type="slidenum">
              <a:rPr lang="pt-BR" smtClean="0"/>
              <a:t>‹N°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92324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68EBA67-EC9D-637F-3F99-0B6B5528D9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pt-BR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283F763-73EC-BDA7-D0AA-5426226CEFC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pt-BR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476C2C2-5503-EF3B-F235-3FFBBE4410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8DCC-8482-4F17-A55C-80CAFC6C22FC}" type="datetimeFigureOut">
              <a:rPr lang="pt-BR" smtClean="0"/>
              <a:t>17/08/2022</a:t>
            </a:fld>
            <a:endParaRPr lang="pt-B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89ED8DC-2CD8-202E-5E96-D6CFF5911E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C4B5008-A403-3850-56A4-D52F7E8A7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6187-DDB6-4281-8E35-2EC75AFE2CAF}" type="slidenum">
              <a:rPr lang="pt-BR" smtClean="0"/>
              <a:t>‹N°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922441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4567B8F-D7B8-B25F-0120-EE80DF1C8A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pt-BR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2BA5B6E-1F85-8AE8-E119-1359FDC620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F2B9F4D-9BC5-CD9E-ED3D-A7D9867125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8DCC-8482-4F17-A55C-80CAFC6C22FC}" type="datetimeFigureOut">
              <a:rPr lang="pt-BR" smtClean="0"/>
              <a:t>17/08/2022</a:t>
            </a:fld>
            <a:endParaRPr lang="pt-B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3D0FAAF-BB84-B095-C3F4-9169E4A22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843ABD7-0AC9-6DA5-98D9-93FA4F7C4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6187-DDB6-4281-8E35-2EC75AFE2CAF}" type="slidenum">
              <a:rPr lang="pt-BR" smtClean="0"/>
              <a:t>‹N°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67999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26AA00B-B443-C32A-BD5C-3B276939A5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pt-BR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6BB7028-E1D3-CCA9-14BD-C8FEE1FAE2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pt-BR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87BDC0E-6635-B7EF-A2FA-932583C471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pt-BR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0E6C561-D5D7-BAB8-A622-9AED2E137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8DCC-8482-4F17-A55C-80CAFC6C22FC}" type="datetimeFigureOut">
              <a:rPr lang="pt-BR" smtClean="0"/>
              <a:t>17/08/2022</a:t>
            </a:fld>
            <a:endParaRPr lang="pt-B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1CCE9F2-274B-FF32-AAD6-1E17E966A4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99A9C31-A771-929A-EB12-C49724E53F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6187-DDB6-4281-8E35-2EC75AFE2CAF}" type="slidenum">
              <a:rPr lang="pt-BR" smtClean="0"/>
              <a:t>‹N°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52666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8119FFF-DF9E-70B8-FCDD-C8467A75D7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pt-BR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C386B0F-35DC-69FF-4D4C-1FF509327D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0C3035F8-5FAF-A0D1-3438-24F70B2E3D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pt-BR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6289815B-D69D-830E-ED0F-5CB9254F1A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60365748-723B-D263-D70A-ABDCC03D1D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pt-BR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A517CFBE-476C-A6C6-D933-927297E4A8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8DCC-8482-4F17-A55C-80CAFC6C22FC}" type="datetimeFigureOut">
              <a:rPr lang="pt-BR" smtClean="0"/>
              <a:t>17/08/2022</a:t>
            </a:fld>
            <a:endParaRPr lang="pt-B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F2B036EF-84C3-D7C0-38F3-D6041E8A9D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ADB779B-D068-5741-234F-933227484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6187-DDB6-4281-8E35-2EC75AFE2CAF}" type="slidenum">
              <a:rPr lang="pt-BR" smtClean="0"/>
              <a:t>‹N°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62234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5C0A388-6AB7-8691-ECBC-28D74E03CB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pt-BR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28A6C2C-3976-C797-D7BD-E870AF6F7E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8DCC-8482-4F17-A55C-80CAFC6C22FC}" type="datetimeFigureOut">
              <a:rPr lang="pt-BR" smtClean="0"/>
              <a:t>17/08/2022</a:t>
            </a:fld>
            <a:endParaRPr lang="pt-B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28165F59-A396-C63B-BDB3-377D8FEC40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EAD19580-B3FE-883D-A850-9782EC6EF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6187-DDB6-4281-8E35-2EC75AFE2CAF}" type="slidenum">
              <a:rPr lang="pt-BR" smtClean="0"/>
              <a:t>‹N°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00857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38319DA3-47AC-7789-834E-0B9A46EF0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8DCC-8482-4F17-A55C-80CAFC6C22FC}" type="datetimeFigureOut">
              <a:rPr lang="pt-BR" smtClean="0"/>
              <a:t>17/08/2022</a:t>
            </a:fld>
            <a:endParaRPr lang="pt-B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9A65D157-0FBD-143C-0106-37BDE19E2B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5395EA96-77F3-B8E0-ECC7-C35072424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6187-DDB6-4281-8E35-2EC75AFE2CAF}" type="slidenum">
              <a:rPr lang="pt-BR" smtClean="0"/>
              <a:t>‹N°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86969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40CD3F5-F01B-5FDC-37DB-529CADBB76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pt-BR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5930340-BA36-3F7F-F547-457956E3DD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pt-B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3454D7D-A5F0-C1B9-BC55-26C418327B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0ABAFAC-0534-E2D3-2B9E-EADE678EA2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8DCC-8482-4F17-A55C-80CAFC6C22FC}" type="datetimeFigureOut">
              <a:rPr lang="pt-BR" smtClean="0"/>
              <a:t>17/08/2022</a:t>
            </a:fld>
            <a:endParaRPr lang="pt-B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B3D780B-749F-19F8-60DA-B34699C701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B7005AA-8892-4595-C96E-0709C63771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6187-DDB6-4281-8E35-2EC75AFE2CAF}" type="slidenum">
              <a:rPr lang="pt-BR" smtClean="0"/>
              <a:t>‹N°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575557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55BE392-1A1C-A57F-CEBC-A48CCAD90F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pt-BR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E0AD35F7-7BF3-A767-D414-1A3AAEEBEED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5E98109-6B2A-6B07-687F-F1FD8DEEBD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CDC4762-56D5-3DE1-80C1-2FE36A5645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E8DCC-8482-4F17-A55C-80CAFC6C22FC}" type="datetimeFigureOut">
              <a:rPr lang="pt-BR" smtClean="0"/>
              <a:t>17/08/2022</a:t>
            </a:fld>
            <a:endParaRPr lang="pt-B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095C396-3F35-AD61-25CE-E6AE723D2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6E2F408-415C-C3D9-07CA-BD9E53CFA7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C6187-DDB6-4281-8E35-2EC75AFE2CAF}" type="slidenum">
              <a:rPr lang="pt-BR" smtClean="0"/>
              <a:t>‹N°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97823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A7CD911A-95E1-682A-F8DB-A2AD1AD4B1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pt-BR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24F8A94-724A-AEB7-E8CA-2A572B8F02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pt-BR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602880-4FE0-829E-A975-77AB873981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7E8DCC-8482-4F17-A55C-80CAFC6C22FC}" type="datetimeFigureOut">
              <a:rPr lang="pt-BR" smtClean="0"/>
              <a:t>17/08/2022</a:t>
            </a:fld>
            <a:endParaRPr lang="pt-B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DABAECE-E3C6-745C-01CF-C525DF091E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8643358-74A4-E361-6C98-84654385A0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FC6187-DDB6-4281-8E35-2EC75AFE2CAF}" type="slidenum">
              <a:rPr lang="pt-BR" smtClean="0"/>
              <a:t>‹N°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49495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293022A-FD67-8BBC-5DC0-0AC1C10235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2370221"/>
            <a:ext cx="9144000" cy="1139742"/>
          </a:xfrm>
        </p:spPr>
        <p:txBody>
          <a:bodyPr/>
          <a:lstStyle/>
          <a:p>
            <a:r>
              <a:rPr lang="pt-BR" dirty="0"/>
              <a:t>Material Supplementary</a:t>
            </a:r>
          </a:p>
        </p:txBody>
      </p:sp>
    </p:spTree>
    <p:extLst>
      <p:ext uri="{BB962C8B-B14F-4D97-AF65-F5344CB8AC3E}">
        <p14:creationId xmlns:p14="http://schemas.microsoft.com/office/powerpoint/2010/main" val="17115887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id="{DD556517-50E8-90A3-6E80-7988E008E5A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35138816"/>
              </p:ext>
            </p:extLst>
          </p:nvPr>
        </p:nvGraphicFramePr>
        <p:xfrm>
          <a:off x="3192378" y="191183"/>
          <a:ext cx="6526263" cy="6475633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500664">
                  <a:extLst>
                    <a:ext uri="{9D8B030D-6E8A-4147-A177-3AD203B41FA5}">
                      <a16:colId xmlns:a16="http://schemas.microsoft.com/office/drawing/2014/main" val="4229158967"/>
                    </a:ext>
                  </a:extLst>
                </a:gridCol>
                <a:gridCol w="1529808">
                  <a:extLst>
                    <a:ext uri="{9D8B030D-6E8A-4147-A177-3AD203B41FA5}">
                      <a16:colId xmlns:a16="http://schemas.microsoft.com/office/drawing/2014/main" val="306565025"/>
                    </a:ext>
                  </a:extLst>
                </a:gridCol>
                <a:gridCol w="1593991">
                  <a:extLst>
                    <a:ext uri="{9D8B030D-6E8A-4147-A177-3AD203B41FA5}">
                      <a16:colId xmlns:a16="http://schemas.microsoft.com/office/drawing/2014/main" val="991897954"/>
                    </a:ext>
                  </a:extLst>
                </a:gridCol>
                <a:gridCol w="901800">
                  <a:extLst>
                    <a:ext uri="{9D8B030D-6E8A-4147-A177-3AD203B41FA5}">
                      <a16:colId xmlns:a16="http://schemas.microsoft.com/office/drawing/2014/main" val="449074721"/>
                    </a:ext>
                  </a:extLst>
                </a:gridCol>
              </a:tblGrid>
              <a:tr h="42332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Parameter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HU</a:t>
                      </a:r>
                      <a:r>
                        <a:rPr lang="en-US" sz="900" baseline="30000">
                          <a:effectLst/>
                        </a:rPr>
                        <a:t>+</a:t>
                      </a:r>
                      <a:r>
                        <a:rPr lang="en-US" sz="900">
                          <a:effectLst/>
                        </a:rPr>
                        <a:t> (N=31)</a:t>
                      </a:r>
                      <a:endParaRPr lang="pt-BR" sz="9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Mean ± SD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HU</a:t>
                      </a:r>
                      <a:r>
                        <a:rPr lang="en-US" sz="900" baseline="30000">
                          <a:effectLst/>
                        </a:rPr>
                        <a:t>-</a:t>
                      </a:r>
                      <a:r>
                        <a:rPr lang="en-US" sz="900">
                          <a:effectLst/>
                        </a:rPr>
                        <a:t> (N=106) </a:t>
                      </a:r>
                      <a:endParaRPr lang="pt-BR" sz="9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Mean ± SD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p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251986362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Hemoglobin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3440209393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HbF, %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13.34±6.15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10.70±6.45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1153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3859296582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HbS, %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81.71±6.01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83.99±6.71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1968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3817952571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Hemolysis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1127342947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RBC, x10</a:t>
                      </a:r>
                      <a:r>
                        <a:rPr lang="en-US" sz="1050" baseline="30000"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/m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2.67±0.49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3.16±0.84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0054*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3434144546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Hemoglobin, g/d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8.93±1.16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8.98±1.55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8811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1252527909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Hematocrit, %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25.87±3.67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26.43±4.69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5414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2472176688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Reticulocyte, %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6.31±2.31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7.42±2.82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0516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409957849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Reticulocyte, /m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167767±68606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221709±83915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0017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2478555062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MCV, f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97.94±11.02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85.25±9.60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&lt;0.0001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2686064004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MCH, pg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33.86±3.70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29.14±3.80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&lt;0.0001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3825940702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MCHC, %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34.62±1.42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34.13±1.74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1549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3628589108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RDW, %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19.64±2.66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20.03±3.18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5347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409527614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Haptoglobin, mg/d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10.53±24.12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5.86±0.14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8067*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1048820191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effectLst/>
                        </a:rPr>
                        <a:t>Leukocytes</a:t>
                      </a:r>
                      <a:endParaRPr lang="pt-B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1966073969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WBC, /mL 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10106±3727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12731±4587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0043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1579495455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Neutrophil, /m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4767±2210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5141±2351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4344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3614611232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Eosinophil, /m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439±390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966±913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0005*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3289770361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Lymphocyte, /m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4065±1670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5332±2880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0504*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3104369839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Monocyte, m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740±388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1011±544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0089*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854474501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Basophile, m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45±75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103±111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0049*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3013044185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Platelets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3765896325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Platelet, x10</a:t>
                      </a:r>
                      <a:r>
                        <a:rPr lang="en-US" sz="105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/m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360±106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377±130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5101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1343604725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MPV, f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6.69±1.93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6.72±1.63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9310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112621685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Hemolytic plus hepatic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1343387031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Total bilirubin, mg/d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2.25±1.22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2.16±1.31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7428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977500219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Direct bilirubin, mg/d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46±0.13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42±0.14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2010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4145349606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Indirect bilirubin, mg/d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1.79±1.16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1.74±1.26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8446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1006882062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Lactate dehydrogenase, U/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957.68±272.14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1154.58±482.97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0671*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3746470874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Iron serum, mcg/d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102.34±46.39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83.22±28.53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0483*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2653069613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Aspartate aminotransferase, U/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43.97±20.25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48.53±15.51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1842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1161388999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Lipids and glucose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2142888755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Total cholesterol, mg/d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122.13±16.27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129.21±23.82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0895*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3970379747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HDL-C, mg/d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40.52±13.74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40.09±12.25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8680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1810712363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LDL-C, mg/d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64.86±15.93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71.48±21.45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1137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2352505371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>
                          <a:solidFill>
                            <a:schemeClr val="tx1"/>
                          </a:solidFill>
                          <a:effectLst/>
                        </a:rPr>
                        <a:t>Triglycerides, mg/dL</a:t>
                      </a:r>
                      <a:endParaRPr lang="pt-B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83.77±33.39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88.11±34.83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0.5398*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199647637"/>
                  </a:ext>
                </a:extLst>
              </a:tr>
              <a:tr h="16293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effectLst/>
                        </a:rPr>
                        <a:t>Glucose, mg/dL</a:t>
                      </a:r>
                      <a:endParaRPr lang="pt-B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dirty="0">
                          <a:effectLst/>
                        </a:rPr>
                        <a:t>75.16±14.28</a:t>
                      </a:r>
                      <a:endParaRPr lang="pt-B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dirty="0">
                          <a:effectLst/>
                        </a:rPr>
                        <a:t>70.75±15.24</a:t>
                      </a:r>
                      <a:endParaRPr lang="pt-B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dirty="0">
                          <a:effectLst/>
                        </a:rPr>
                        <a:t>0.1538*</a:t>
                      </a:r>
                      <a:endParaRPr lang="pt-B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6" marR="42216" marT="0" marB="0" anchor="ctr"/>
                </a:tc>
                <a:extLst>
                  <a:ext uri="{0D108BD9-81ED-4DB2-BD59-A6C34878D82A}">
                    <a16:rowId xmlns:a16="http://schemas.microsoft.com/office/drawing/2014/main" val="257942801"/>
                  </a:ext>
                </a:extLst>
              </a:tr>
            </a:tbl>
          </a:graphicData>
        </a:graphic>
      </p:graphicFrame>
      <p:sp>
        <p:nvSpPr>
          <p:cNvPr id="6" name="ZoneTexte 5">
            <a:extLst>
              <a:ext uri="{FF2B5EF4-FFF2-40B4-BE49-F238E27FC236}">
                <a16:creationId xmlns:a16="http://schemas.microsoft.com/office/drawing/2014/main" id="{60306085-76B3-A677-2E7C-610DEFFA17BC}"/>
              </a:ext>
            </a:extLst>
          </p:cNvPr>
          <p:cNvSpPr txBox="1"/>
          <p:nvPr/>
        </p:nvSpPr>
        <p:spPr>
          <a:xfrm>
            <a:off x="0" y="605589"/>
            <a:ext cx="2935705" cy="7160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80340" marR="179070" algn="just">
              <a:lnSpc>
                <a:spcPct val="115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 S1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Laboratory parameters of children with SCA receiving or not HU therapy</a:t>
            </a:r>
            <a:endParaRPr lang="pt-BR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86165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id="{9CC2FD33-CA10-0411-F155-BE568A9479F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9845498"/>
              </p:ext>
            </p:extLst>
          </p:nvPr>
        </p:nvGraphicFramePr>
        <p:xfrm>
          <a:off x="3545522" y="2923064"/>
          <a:ext cx="5100955" cy="2608136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954530">
                  <a:extLst>
                    <a:ext uri="{9D8B030D-6E8A-4147-A177-3AD203B41FA5}">
                      <a16:colId xmlns:a16="http://schemas.microsoft.com/office/drawing/2014/main" val="663734786"/>
                    </a:ext>
                  </a:extLst>
                </a:gridCol>
                <a:gridCol w="1195705">
                  <a:extLst>
                    <a:ext uri="{9D8B030D-6E8A-4147-A177-3AD203B41FA5}">
                      <a16:colId xmlns:a16="http://schemas.microsoft.com/office/drawing/2014/main" val="880679751"/>
                    </a:ext>
                  </a:extLst>
                </a:gridCol>
                <a:gridCol w="1245870">
                  <a:extLst>
                    <a:ext uri="{9D8B030D-6E8A-4147-A177-3AD203B41FA5}">
                      <a16:colId xmlns:a16="http://schemas.microsoft.com/office/drawing/2014/main" val="1856562283"/>
                    </a:ext>
                  </a:extLst>
                </a:gridCol>
                <a:gridCol w="704850">
                  <a:extLst>
                    <a:ext uri="{9D8B030D-6E8A-4147-A177-3AD203B41FA5}">
                      <a16:colId xmlns:a16="http://schemas.microsoft.com/office/drawing/2014/main" val="3004263504"/>
                    </a:ext>
                  </a:extLst>
                </a:gridCol>
              </a:tblGrid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Renal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881021773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Urea, mg/dL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19.29±7.27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17.26±5.31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0.1972**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81734508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Creatinine, mg/dL 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0.45±0.10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0.41±0.10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0.0450*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057271640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Hepatic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1098269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Alanine aminotransferase, U/L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17.74±8.83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18.73±10.21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0.6261*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7517065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Total protein, g/dL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7.66±0.68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7.6±0.74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0.7601*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333190363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Albumin, g/dL 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4.40±0.31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4.39±0.52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0.9760**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964710560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Globulin, g/dL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3.26±0.69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3.17±0.75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0.5641*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04266285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Inflammatory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 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267593706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Ferritin, ng/dL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6.22±4.29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12.62±29.24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0.0286**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808952417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</a:rPr>
                        <a:t>C-reactive protein, mg/L</a:t>
                      </a:r>
                      <a:endParaRPr lang="pt-BR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431.08±612.77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261.26±469.31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0.1115*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257195286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dirty="0">
                          <a:effectLst/>
                        </a:rPr>
                        <a:t>Alpha 1 antitrypsin, mg/dL</a:t>
                      </a:r>
                      <a:endParaRPr lang="pt-BR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137.30±32.05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</a:rPr>
                        <a:t>143.75±44.81</a:t>
                      </a:r>
                      <a:endParaRPr lang="pt-B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</a:rPr>
                        <a:t>0.4999*</a:t>
                      </a:r>
                      <a:endParaRPr lang="pt-B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336893264"/>
                  </a:ext>
                </a:extLst>
              </a:tr>
              <a:tr h="179705">
                <a:tc gridSpan="4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BR" sz="7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C: red blood cell, MCH: mean corpuscular hemoglobin, MCV: mean corpuscular volume, MCHC: mean corpuscular hemoglobin concentration, HbS: variant S hemoglobin, HbF: Fetal hemoglobin, RDW: red cell distribution width, HDL-C: high-density lipoprotein cholesterol, LDL-C: low-density lipoprotein cholesterol, WBC: white blood cell, MPV: mean platelet volume, * Independent T test, ** Mann Whitney U test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pt-BR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pt-BR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pt-BR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474755879"/>
                  </a:ext>
                </a:extLst>
              </a:tr>
            </a:tbl>
          </a:graphicData>
        </a:graphic>
      </p:graphicFrame>
      <p:sp>
        <p:nvSpPr>
          <p:cNvPr id="6" name="ZoneTexte 5">
            <a:extLst>
              <a:ext uri="{FF2B5EF4-FFF2-40B4-BE49-F238E27FC236}">
                <a16:creationId xmlns:a16="http://schemas.microsoft.com/office/drawing/2014/main" id="{B57DC567-C80D-DA72-2930-9A9650468291}"/>
              </a:ext>
            </a:extLst>
          </p:cNvPr>
          <p:cNvSpPr txBox="1"/>
          <p:nvPr/>
        </p:nvSpPr>
        <p:spPr>
          <a:xfrm>
            <a:off x="1058779" y="2339310"/>
            <a:ext cx="6096000" cy="3906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80340" marR="179070" algn="just">
              <a:lnSpc>
                <a:spcPct val="115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1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Continued</a:t>
            </a:r>
            <a:endParaRPr lang="pt-BR" sz="2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64965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m 1">
            <a:extLst>
              <a:ext uri="{FF2B5EF4-FFF2-40B4-BE49-F238E27FC236}">
                <a16:creationId xmlns:a16="http://schemas.microsoft.com/office/drawing/2014/main" id="{76CBD3AC-A9C5-35C7-7789-56084B5CE85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6068" y="1180795"/>
            <a:ext cx="6440170" cy="4010025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1A6933CD-B092-C8C2-555E-A2099E2A3AE6}"/>
              </a:ext>
            </a:extLst>
          </p:cNvPr>
          <p:cNvSpPr txBox="1"/>
          <p:nvPr/>
        </p:nvSpPr>
        <p:spPr>
          <a:xfrm>
            <a:off x="2191966" y="5190820"/>
            <a:ext cx="6300281" cy="742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Laboratory parameters of children with SCA without HU treatment according to TCD. TCD: Transcranial Doppler, RBC: red blood cell, MCH: mean corpuscular hemoglobin, MCV: mean corpuscular volume, RDW: red cell distribution width, WBC: white blood cell, AST: alanine aminotransferase, A1AST: alpha 1 antitrypsin, * ANOVA test, ** Kruskal Wallis test</a:t>
            </a:r>
            <a:endParaRPr lang="pt-B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936874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577</Words>
  <Application>Microsoft Office PowerPoint</Application>
  <PresentationFormat>Grand écran</PresentationFormat>
  <Paragraphs>208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Thème Office</vt:lpstr>
      <vt:lpstr>Material Supplementary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aterial Supplementary</dc:title>
  <dc:creator>corynne Adanho</dc:creator>
  <cp:lastModifiedBy>corynne Adanho</cp:lastModifiedBy>
  <cp:revision>1</cp:revision>
  <dcterms:created xsi:type="dcterms:W3CDTF">2022-08-17T16:35:39Z</dcterms:created>
  <dcterms:modified xsi:type="dcterms:W3CDTF">2022-08-17T16:48:08Z</dcterms:modified>
</cp:coreProperties>
</file>